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3" r:id="rId3"/>
    <p:sldId id="262" r:id="rId4"/>
    <p:sldId id="261" r:id="rId5"/>
    <p:sldId id="264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336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02B815AE-52EE-4594-8386-326E885BEF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1412776"/>
            <a:ext cx="8677656" cy="348081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86014DE-4696-4532-9EC8-05610A09A1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64088" y="1700808"/>
            <a:ext cx="2883658" cy="205453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AA637F5-FDAC-40E1-A871-C9C082D7F4EC}"/>
              </a:ext>
            </a:extLst>
          </p:cNvPr>
          <p:cNvSpPr txBox="1"/>
          <p:nvPr/>
        </p:nvSpPr>
        <p:spPr>
          <a:xfrm>
            <a:off x="3995936" y="1916832"/>
            <a:ext cx="309634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           ZO-1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4DC2B9B-BCFB-45FC-B129-C157A976FA8D}"/>
              </a:ext>
            </a:extLst>
          </p:cNvPr>
          <p:cNvSpPr txBox="1"/>
          <p:nvPr/>
        </p:nvSpPr>
        <p:spPr>
          <a:xfrm rot="18117680">
            <a:off x="5751338" y="84160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4407C1A-9B33-451D-9EBA-44A7AF4C67B3}"/>
              </a:ext>
            </a:extLst>
          </p:cNvPr>
          <p:cNvSpPr txBox="1"/>
          <p:nvPr/>
        </p:nvSpPr>
        <p:spPr>
          <a:xfrm rot="18117680">
            <a:off x="6156102" y="861957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72361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2D912E76-B231-498D-AEE5-9DCEE197E64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765" y="908720"/>
            <a:ext cx="8229600" cy="3301089"/>
          </a:xfrm>
          <a:prstGeom prst="rect">
            <a:avLst/>
          </a:prstGeom>
        </p:spPr>
      </p:pic>
      <p:pic>
        <p:nvPicPr>
          <p:cNvPr id="7" name="内容占位符 3">
            <a:extLst>
              <a:ext uri="{FF2B5EF4-FFF2-40B4-BE49-F238E27FC236}">
                <a16:creationId xmlns:a16="http://schemas.microsoft.com/office/drawing/2014/main" id="{184CEAEF-8B8C-4D9C-854E-BFF606F3B03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421" t="37897" r="-571" b="40720"/>
          <a:stretch/>
        </p:blipFill>
        <p:spPr>
          <a:xfrm>
            <a:off x="4083157" y="1793095"/>
            <a:ext cx="5904656" cy="1303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DC4BFC1-083F-44B1-84CE-217848EEC22E}"/>
              </a:ext>
            </a:extLst>
          </p:cNvPr>
          <p:cNvSpPr txBox="1"/>
          <p:nvPr/>
        </p:nvSpPr>
        <p:spPr>
          <a:xfrm rot="18117680">
            <a:off x="5116810" y="1010430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5A0C618-6490-4723-A2EF-B803407EBA36}"/>
              </a:ext>
            </a:extLst>
          </p:cNvPr>
          <p:cNvSpPr txBox="1"/>
          <p:nvPr/>
        </p:nvSpPr>
        <p:spPr>
          <a:xfrm rot="18117680">
            <a:off x="5517655" y="1004279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5BBB4C1-7C9F-42CB-9494-3DE75D523CCA}"/>
              </a:ext>
            </a:extLst>
          </p:cNvPr>
          <p:cNvSpPr txBox="1"/>
          <p:nvPr/>
        </p:nvSpPr>
        <p:spPr>
          <a:xfrm>
            <a:off x="3678365" y="2079504"/>
            <a:ext cx="258490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Occluadin</a:t>
            </a:r>
            <a:endParaRPr lang="en-US" altLang="zh-CN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F8AD95F-B929-4124-BB03-C2EC14536FB9}"/>
              </a:ext>
            </a:extLst>
          </p:cNvPr>
          <p:cNvSpPr txBox="1"/>
          <p:nvPr/>
        </p:nvSpPr>
        <p:spPr>
          <a:xfrm>
            <a:off x="251520" y="4632519"/>
            <a:ext cx="913801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xplain:  As you can see, the WB band of  </a:t>
            </a:r>
            <a:r>
              <a:rPr lang="en-US" altLang="zh-CN" dirty="0" err="1"/>
              <a:t>Occluadin</a:t>
            </a:r>
            <a:r>
              <a:rPr lang="en-US" altLang="zh-CN" dirty="0"/>
              <a:t> shown in the Figure3 was different from</a:t>
            </a:r>
          </a:p>
          <a:p>
            <a:r>
              <a:rPr lang="en-US" altLang="zh-CN" dirty="0"/>
              <a:t>the band in the original material we provide here. We have tried to  find the one exhibiting</a:t>
            </a:r>
          </a:p>
          <a:p>
            <a:r>
              <a:rPr lang="en-US" altLang="zh-CN" dirty="0"/>
              <a:t>the band showed in the Figure3, but we are sorry for that it was lost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94408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BED034B6-7ED9-41D4-B04B-2340476E0BD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1124744"/>
            <a:ext cx="8229600" cy="330108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9840996-95C2-43D5-8DA4-F6BFF0B939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3100" y="1124744"/>
            <a:ext cx="3462036" cy="471939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BE4A5BE-733E-4BA4-87CD-BF15F9127ABC}"/>
              </a:ext>
            </a:extLst>
          </p:cNvPr>
          <p:cNvSpPr txBox="1"/>
          <p:nvPr/>
        </p:nvSpPr>
        <p:spPr>
          <a:xfrm rot="18117680">
            <a:off x="5132867" y="179150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B3AB26A-0DC9-487B-8C0E-CF8F1C5A105C}"/>
              </a:ext>
            </a:extLst>
          </p:cNvPr>
          <p:cNvSpPr txBox="1"/>
          <p:nvPr/>
        </p:nvSpPr>
        <p:spPr>
          <a:xfrm rot="18117680">
            <a:off x="5505597" y="1791505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197F8CF-9AB7-4536-ACD0-31DEC103EE52}"/>
              </a:ext>
            </a:extLst>
          </p:cNvPr>
          <p:cNvSpPr txBox="1"/>
          <p:nvPr/>
        </p:nvSpPr>
        <p:spPr>
          <a:xfrm>
            <a:off x="4222304" y="2920411"/>
            <a:ext cx="219928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Claudin-1</a:t>
            </a:r>
          </a:p>
        </p:txBody>
      </p:sp>
    </p:spTree>
    <p:extLst>
      <p:ext uri="{BB962C8B-B14F-4D97-AF65-F5344CB8AC3E}">
        <p14:creationId xmlns:p14="http://schemas.microsoft.com/office/powerpoint/2010/main" val="42877203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BDB9D95-4EC8-4574-96F7-BE9787BE43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1412776"/>
            <a:ext cx="8677656" cy="348081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55081F5-4B33-4CAF-A783-4E32ACE6B3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5047" y="1196752"/>
            <a:ext cx="3023878" cy="408467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F360E56-5A0B-47C6-A2F5-793C80337C98}"/>
              </a:ext>
            </a:extLst>
          </p:cNvPr>
          <p:cNvSpPr txBox="1"/>
          <p:nvPr/>
        </p:nvSpPr>
        <p:spPr>
          <a:xfrm rot="18117680">
            <a:off x="6483435" y="2770243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19 Overexpression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A5DAFBC-D34D-4508-9DC6-A86F3A155023}"/>
              </a:ext>
            </a:extLst>
          </p:cNvPr>
          <p:cNvSpPr txBox="1"/>
          <p:nvPr/>
        </p:nvSpPr>
        <p:spPr>
          <a:xfrm rot="18117680">
            <a:off x="7052094" y="2770244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ntrol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AF473A-18B1-4EB0-A7F8-A86ECF9E76EA}"/>
              </a:ext>
            </a:extLst>
          </p:cNvPr>
          <p:cNvSpPr txBox="1"/>
          <p:nvPr/>
        </p:nvSpPr>
        <p:spPr>
          <a:xfrm>
            <a:off x="4427984" y="4030134"/>
            <a:ext cx="352839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99832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C50788-FA2C-4430-844C-7A06E733DF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7504" y="5085184"/>
            <a:ext cx="9649072" cy="128560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CN" sz="2000" dirty="0"/>
              <a:t>Explain: We tried to find the original data of Figure 5, but we think we lost it.  </a:t>
            </a:r>
            <a:endParaRPr lang="zh-CN" altLang="en-US" sz="2000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2160278-9BDF-471C-8E7F-C53C53311460}"/>
              </a:ext>
            </a:extLst>
          </p:cNvPr>
          <p:cNvGrpSpPr/>
          <p:nvPr/>
        </p:nvGrpSpPr>
        <p:grpSpPr>
          <a:xfrm>
            <a:off x="1763688" y="764704"/>
            <a:ext cx="4536504" cy="4515024"/>
            <a:chOff x="899592" y="908720"/>
            <a:chExt cx="4536504" cy="451502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90DD29A-7113-4A2C-B091-B95BB4294D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9592" y="908720"/>
              <a:ext cx="3239005" cy="3985247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97B26F2-2A27-4378-92C7-4591A0917BD6}"/>
                </a:ext>
              </a:extLst>
            </p:cNvPr>
            <p:cNvSpPr txBox="1"/>
            <p:nvPr/>
          </p:nvSpPr>
          <p:spPr>
            <a:xfrm>
              <a:off x="4644008" y="1268760"/>
              <a:ext cx="792088" cy="4154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400" dirty="0"/>
                <a:t>?</a:t>
              </a:r>
            </a:p>
            <a:p>
              <a:r>
                <a:rPr lang="en-US" altLang="zh-CN" sz="4400" dirty="0"/>
                <a:t>?</a:t>
              </a:r>
            </a:p>
            <a:p>
              <a:r>
                <a:rPr lang="en-US" altLang="zh-CN" sz="4400" dirty="0"/>
                <a:t>?</a:t>
              </a:r>
            </a:p>
            <a:p>
              <a:r>
                <a:rPr lang="en-US" altLang="zh-CN" sz="4400" dirty="0"/>
                <a:t>?</a:t>
              </a:r>
            </a:p>
            <a:p>
              <a:r>
                <a:rPr lang="en-US" altLang="zh-CN" sz="4400" dirty="0"/>
                <a:t>?</a:t>
              </a:r>
            </a:p>
            <a:p>
              <a:endParaRPr lang="zh-CN" altLang="en-US" sz="4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46282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全屏显示(4:3)</PresentationFormat>
  <Paragraphs>2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ang hao</cp:lastModifiedBy>
  <cp:revision>20</cp:revision>
  <dcterms:created xsi:type="dcterms:W3CDTF">2018-09-21T07:45:23Z</dcterms:created>
  <dcterms:modified xsi:type="dcterms:W3CDTF">2018-10-20T13:16:50Z</dcterms:modified>
</cp:coreProperties>
</file>